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handoutMasterIdLst>
    <p:handoutMasterId r:id="rId4"/>
  </p:handoutMasterIdLst>
  <p:sldIdLst>
    <p:sldId id="446" r:id="rId2"/>
  </p:sldIdLst>
  <p:sldSz cx="6858000" cy="9144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793" userDrawn="1">
          <p15:clr>
            <a:srgbClr val="A4A3A4"/>
          </p15:clr>
        </p15:guide>
        <p15:guide id="3" orient="horz" pos="469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55A11"/>
    <a:srgbClr val="3003E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4517" autoAdjust="0"/>
    <p:restoredTop sz="95320" autoAdjust="0"/>
  </p:normalViewPr>
  <p:slideViewPr>
    <p:cSldViewPr snapToGrid="0" showGuides="1">
      <p:cViewPr varScale="1">
        <p:scale>
          <a:sx n="82" d="100"/>
          <a:sy n="82" d="100"/>
        </p:scale>
        <p:origin x="1901" y="77"/>
      </p:cViewPr>
      <p:guideLst>
        <p:guide pos="3793"/>
        <p:guide orient="horz" pos="469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C4FF141-4FEF-4333-B11C-584026D8E905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8AE835B-F104-4314-81BB-D3026DB4889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117005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8A00CD-9A91-4D8E-B2BC-4F2F51EAF694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1E9546-9BC9-43B9-B151-2C08AC049B1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02935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5076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79963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754253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064142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91270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38710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43356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31217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91120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221232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26347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661601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5793982" y="8867002"/>
            <a:ext cx="11199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ble 1 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0" y="133350"/>
            <a:ext cx="4017818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100" b="1" dirty="0"/>
              <a:t>Pathway-focused </a:t>
            </a:r>
            <a:r>
              <a:rPr lang="en-US" altLang="ko-KR" sz="1100" b="1" dirty="0" err="1"/>
              <a:t>miScript</a:t>
            </a:r>
            <a:r>
              <a:rPr lang="en-US" altLang="ko-KR" sz="1100" b="1" dirty="0"/>
              <a:t> miRNA PCR Arrays (Cancer pathway)</a:t>
            </a:r>
            <a:endParaRPr lang="ko-KR" altLang="en-US" sz="1100" dirty="0"/>
          </a:p>
        </p:txBody>
      </p:sp>
      <p:graphicFrame>
        <p:nvGraphicFramePr>
          <p:cNvPr id="3" name="표 2">
            <a:extLst>
              <a:ext uri="{FF2B5EF4-FFF2-40B4-BE49-F238E27FC236}">
                <a16:creationId xmlns:a16="http://schemas.microsoft.com/office/drawing/2014/main" id="{30C9F7A5-2E0D-473D-8E0E-3B3B9CADADF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10474417"/>
              </p:ext>
            </p:extLst>
          </p:nvPr>
        </p:nvGraphicFramePr>
        <p:xfrm>
          <a:off x="84620" y="613709"/>
          <a:ext cx="6582396" cy="8103561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097066">
                  <a:extLst>
                    <a:ext uri="{9D8B030D-6E8A-4147-A177-3AD203B41FA5}">
                      <a16:colId xmlns:a16="http://schemas.microsoft.com/office/drawing/2014/main" val="92344472"/>
                    </a:ext>
                  </a:extLst>
                </a:gridCol>
                <a:gridCol w="548533">
                  <a:extLst>
                    <a:ext uri="{9D8B030D-6E8A-4147-A177-3AD203B41FA5}">
                      <a16:colId xmlns:a16="http://schemas.microsoft.com/office/drawing/2014/main" val="2951635913"/>
                    </a:ext>
                  </a:extLst>
                </a:gridCol>
                <a:gridCol w="548533">
                  <a:extLst>
                    <a:ext uri="{9D8B030D-6E8A-4147-A177-3AD203B41FA5}">
                      <a16:colId xmlns:a16="http://schemas.microsoft.com/office/drawing/2014/main" val="2436510309"/>
                    </a:ext>
                  </a:extLst>
                </a:gridCol>
                <a:gridCol w="548533">
                  <a:extLst>
                    <a:ext uri="{9D8B030D-6E8A-4147-A177-3AD203B41FA5}">
                      <a16:colId xmlns:a16="http://schemas.microsoft.com/office/drawing/2014/main" val="757501361"/>
                    </a:ext>
                  </a:extLst>
                </a:gridCol>
                <a:gridCol w="548533">
                  <a:extLst>
                    <a:ext uri="{9D8B030D-6E8A-4147-A177-3AD203B41FA5}">
                      <a16:colId xmlns:a16="http://schemas.microsoft.com/office/drawing/2014/main" val="4240126697"/>
                    </a:ext>
                  </a:extLst>
                </a:gridCol>
                <a:gridCol w="1097066">
                  <a:extLst>
                    <a:ext uri="{9D8B030D-6E8A-4147-A177-3AD203B41FA5}">
                      <a16:colId xmlns:a16="http://schemas.microsoft.com/office/drawing/2014/main" val="2343450718"/>
                    </a:ext>
                  </a:extLst>
                </a:gridCol>
                <a:gridCol w="479162">
                  <a:extLst>
                    <a:ext uri="{9D8B030D-6E8A-4147-A177-3AD203B41FA5}">
                      <a16:colId xmlns:a16="http://schemas.microsoft.com/office/drawing/2014/main" val="1482060577"/>
                    </a:ext>
                  </a:extLst>
                </a:gridCol>
                <a:gridCol w="617904">
                  <a:extLst>
                    <a:ext uri="{9D8B030D-6E8A-4147-A177-3AD203B41FA5}">
                      <a16:colId xmlns:a16="http://schemas.microsoft.com/office/drawing/2014/main" val="932739795"/>
                    </a:ext>
                  </a:extLst>
                </a:gridCol>
                <a:gridCol w="548533">
                  <a:extLst>
                    <a:ext uri="{9D8B030D-6E8A-4147-A177-3AD203B41FA5}">
                      <a16:colId xmlns:a16="http://schemas.microsoft.com/office/drawing/2014/main" val="2489496585"/>
                    </a:ext>
                  </a:extLst>
                </a:gridCol>
                <a:gridCol w="548533">
                  <a:extLst>
                    <a:ext uri="{9D8B030D-6E8A-4147-A177-3AD203B41FA5}">
                      <a16:colId xmlns:a16="http://schemas.microsoft.com/office/drawing/2014/main" val="536797893"/>
                    </a:ext>
                  </a:extLst>
                </a:gridCol>
              </a:tblGrid>
              <a:tr h="24149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RNA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-V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K-V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-DKC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K-DKC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RNA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-V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K-V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-DKC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K-DKC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9405027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let-7a-5p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 (</a:t>
                      </a:r>
                      <a:r>
                        <a:rPr lang="en-US" altLang="ko-KR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0.1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9(±0.2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6(±0.1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3(±0.2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25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9(±0.05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7(±0.1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2(±0.1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906298124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33b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0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7(±0.0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9(±0.1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(±0.0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50-5p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0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(±0.0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(±0.0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2(±0.09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2648150126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22-5p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0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6(±0.1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3(±0.0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(±0.0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let-7i-5p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2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2(±0.4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0(±0.2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6(±0.6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1779890099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20b-5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3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1(±0.1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7(±0.1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0(±0.0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27b-3p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3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7(±0.4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8(±0.4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8(±0.3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4111171931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335-5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6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(±0.2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08(±6.0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(±0.0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7-5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1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5(±0.2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1(±0.35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4(±0.2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355887348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96a-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1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9(±0.1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1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1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27-5p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1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96(±2.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1(±0.0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0(±0.0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4073786868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25a-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49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6(±0.6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4(±0.7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7(±0.6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29a-3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5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2(±0.5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6(±0.4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4(±0.4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441688514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42-5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4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3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2(±0.29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2(±1.49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91-5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2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1(±0.4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0(±0.4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1(±0.3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2398372032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96-5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2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4(±0.4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9(±0.35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(±0.0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let-7d-5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1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9(±0.2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(±0.15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4(±0.1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3305008115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222-3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4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4(±0.45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6(±0.6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3(±0.3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9-5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0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8(±0.25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(±0.0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9(±0.05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3480267822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48b-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4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7(±0.3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4(±0.45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6(±0.3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let-7f-5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1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8(±0.0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4(±0.1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1(0.0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4088531189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92a-3p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45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3(±0.6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8(±0.6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0(±0.5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0a-5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0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6(±0.0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7(±0.0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1(±0.05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378469997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8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4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0(±0.0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5(±0.15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3(±0.1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81b-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1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6(±0.19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6(±0.1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(±0.0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2530703522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214-3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0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2(±0.09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(±0.0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7(±0.0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5b-5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4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6(±0.6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1(0.6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4(±0.5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1666894445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5a-5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2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1(±0.35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4(±0.3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8(±0.2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6-5p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2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1(±0.5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2(±0.39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0(±0.3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2774592993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378a-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2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3(±0.4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1(±0.5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8(±0.35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210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0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4(±0.2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1(±0.1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5(±0.2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1145108719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let-7b-5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0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3(±0.0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6(±0.0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(±0.0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7-5p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2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3(±0.3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(±0.2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0(±0.1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4129004848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205-5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1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8(±0.2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(±0.2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6(±0.1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98-5p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1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1(±0.3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(±0.1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6(±0.1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2262823645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81a-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0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4(±0.1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6(±0.1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0(±0.05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34a-5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2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0(±0.35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3(±0.5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4(±0.2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333355043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30a-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39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6(±0.4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(±0.29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0(±0.3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25-3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4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(±0.25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1(±0.19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7(±0.1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1052437849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40-5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3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5(±0.69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8(±0.3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3(±0.4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44-3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0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2(±3.3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4(±0.0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5(±0.3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2768124875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20a-5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2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0(±0.5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9(±0.4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0(±0.3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2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3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9(±0.5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3(±0.5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5(±0.39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1725594006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46b-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1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2(±0.2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5(±0.1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(±0.1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43-3p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0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6(±0.0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7(±0.0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7(±0.0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2901126172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32-3p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2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0(±0.5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2(±0.4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7(±0.5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215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0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7(±0.1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8(±0.0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1(±0.2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3234499434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93b-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0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3(±0.1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5(±0.0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8(±0.0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9a-3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4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1(±0.5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(±0.5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3(±0.2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534852172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83-5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35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0(±0.5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5(±0.3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7(±0.3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93a-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0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6(±0.0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8(±0.0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7(±0.09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2810225280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34c-5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4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(±0.3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1(±0.19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8(±0.1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8a-5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4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3(±0.7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(±0.75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0(±0.5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3234464583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30c-5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1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9(±0.3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2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4(±0.19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25b-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2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(±0.2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1(±0.3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1(±0.15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1705431393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48a-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3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7(±0.4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8(±0.3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7(±0.3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26-3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2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3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(±0.2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9(±0.1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2232043420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0--miR-134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0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4(±0.09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4(±0.3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4(±0.0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27a-3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3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(±0.4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9(±0.4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7(±0.29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787010487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let-7g-5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09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1(±0.4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4(±0.2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9(±0.4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37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1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5(±0.0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8(±0.0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4(±0.0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3010900034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38-5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0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1(±0.2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2(±0.1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3(±0.1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49-5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4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7(±0.6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7(±0.4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5(±0.4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58035258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373-3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2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2(±0.3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8(±0.1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9(±0.29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23b-3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4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4(±0.5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7(±0.5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9(±0.4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1022971242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let-7c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1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2(±0.1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1(±0.09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6(±0.1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203a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05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9(±0.0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7(±0.1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6(±0.0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2606065145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let-7e-5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3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8(±0.2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(±0.1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9(±0.1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32-5p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0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6(±0.09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7(±0.2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5(±0.0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1465663779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218-5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1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9(±0.3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6(±0.2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3(±0.29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81c-5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1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5(±0.2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0(±0.2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1(±0.0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4078662659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29b-3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3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3(±0.3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8(±0.3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0(±0.2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-miR-39-3p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1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3(±0.2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8(±0.2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(±0.05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3744394538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46a-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1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(±0.0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4(±0.05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5(±0.0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-miR-39-3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0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(±0.3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(±0.1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7(±0.1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3134849365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35b-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0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6(±0.1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(±0.05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4(±0.09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ORD61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19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4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4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2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3311919823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2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2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9(±0.19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6(±0.0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(±0.1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ORD68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4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3(±0.8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2(±0.6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7(±0.59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2237827035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24-3p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1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7(±0.0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(±0.1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3(±0.0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ORD72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2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5(±0.4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2(±0.5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4(±0.2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4200927498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21-5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19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9(±0.3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4(±0.3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7(±0.2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ORD95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2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5(±0.3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(±0.3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7(±0.29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384241421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81d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0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9(±0.05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6(±0.05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9(±0.0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ORD96A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2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5(±0.5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1(±0.4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3(±0.3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1643910363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301a-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49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2(±0.6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5(±0.6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3(±0.2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NU6B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1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0(±0.1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6(±0.1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5(±0.0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3918382905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200c-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0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2(±0.09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(±0.0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9(±0.05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RTC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4.2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2(±4.3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7(±3.70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0(±3.4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2970942356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00-5p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0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7(±0.1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1(±0.0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4(±0.0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RTC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5.1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1(±4.8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(±4.0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0(±3.8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1715198842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0b-5p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0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0(±0.05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(±0.1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(±0.0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C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2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7(±0.4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4(±0.5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51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/>
                </a:tc>
                <a:extLst>
                  <a:ext uri="{0D108BD9-81ED-4DB2-BD59-A6C34878D82A}">
                    <a16:rowId xmlns:a16="http://schemas.microsoft.com/office/drawing/2014/main" val="2061378672"/>
                  </a:ext>
                </a:extLst>
              </a:tr>
              <a:tr h="1637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a-miR-155-5p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18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(±0.05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4(±0.14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9(±0.13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C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±0.17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7(±0.36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9(±0.4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4(±0.42)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660634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452207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176</TotalTime>
  <Words>1651</Words>
  <Application>Microsoft Office PowerPoint</Application>
  <PresentationFormat>화면 슬라이드 쇼(4:3)</PresentationFormat>
  <Paragraphs>49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배정아</dc:creator>
  <cp:lastModifiedBy>user</cp:lastModifiedBy>
  <cp:revision>821</cp:revision>
  <cp:lastPrinted>2020-12-14T02:52:41Z</cp:lastPrinted>
  <dcterms:created xsi:type="dcterms:W3CDTF">2017-02-20T02:17:55Z</dcterms:created>
  <dcterms:modified xsi:type="dcterms:W3CDTF">2021-05-12T02:51:10Z</dcterms:modified>
</cp:coreProperties>
</file>